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88957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271715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354473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437230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51998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602746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58397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56952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55506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54061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52616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747487" y="51171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47487" y="497262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747487" y="48281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47487" y="46835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47487" y="45390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47487" y="43945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47487" y="425004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47487" y="41055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747487" y="39610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747487" y="38164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747487" y="367198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747487" y="35274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747487" y="338295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747487" y="323843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747487" y="309391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747487" y="294940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747487" y="280488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747487" y="26603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747487" y="251585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747487" y="23713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747487" y="222682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747487" y="20823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747487" y="193779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747487" y="17932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747487" y="164876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747487" y="15042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747487" y="135973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747487" y="12152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747487" y="107069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30336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13094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95852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78609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561367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30336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874560" y="3527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581686" y="3527467"/>
              <a:ext cx="3292874" cy="0"/>
            </a:xfrm>
            <a:custGeom>
              <a:avLst/>
              <a:pathLst>
                <a:path w="3292874" h="0">
                  <a:moveTo>
                    <a:pt x="32928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581686" y="3527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5956077" y="2226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668562" y="2226824"/>
              <a:ext cx="3287514" cy="0"/>
            </a:xfrm>
            <a:custGeom>
              <a:avLst/>
              <a:pathLst>
                <a:path w="3287514" h="0">
                  <a:moveTo>
                    <a:pt x="32875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668562" y="2226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5814199" y="39610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567173" y="3961014"/>
              <a:ext cx="3247025" cy="0"/>
            </a:xfrm>
            <a:custGeom>
              <a:avLst/>
              <a:pathLst>
                <a:path w="3247025" h="0">
                  <a:moveTo>
                    <a:pt x="32470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567173" y="39610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5988020" y="1648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791208" y="1648761"/>
              <a:ext cx="3196812" cy="0"/>
            </a:xfrm>
            <a:custGeom>
              <a:avLst/>
              <a:pathLst>
                <a:path w="3196812" h="0">
                  <a:moveTo>
                    <a:pt x="31968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791208" y="1648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5355640" y="5406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107545" y="5406172"/>
              <a:ext cx="3248094" cy="0"/>
            </a:xfrm>
            <a:custGeom>
              <a:avLst/>
              <a:pathLst>
                <a:path w="3248094" h="0">
                  <a:moveTo>
                    <a:pt x="32480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107545" y="5406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5912453" y="26603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676497" y="2660372"/>
              <a:ext cx="3235956" cy="0"/>
            </a:xfrm>
            <a:custGeom>
              <a:avLst/>
              <a:pathLst>
                <a:path w="3235956" h="0">
                  <a:moveTo>
                    <a:pt x="32359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676497" y="26603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5856713" y="3238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604360" y="3238435"/>
              <a:ext cx="3252353" cy="0"/>
            </a:xfrm>
            <a:custGeom>
              <a:avLst/>
              <a:pathLst>
                <a:path w="3252353" h="0">
                  <a:moveTo>
                    <a:pt x="32523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604360" y="3238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5994653" y="1359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833921" y="1359730"/>
              <a:ext cx="3160731" cy="0"/>
            </a:xfrm>
            <a:custGeom>
              <a:avLst/>
              <a:pathLst>
                <a:path w="3160731" h="0">
                  <a:moveTo>
                    <a:pt x="31607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833921" y="1359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5784507" y="4250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546331" y="4250046"/>
              <a:ext cx="3238176" cy="0"/>
            </a:xfrm>
            <a:custGeom>
              <a:avLst/>
              <a:pathLst>
                <a:path w="3238176" h="0">
                  <a:moveTo>
                    <a:pt x="32381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546331" y="4250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5912050" y="2949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631717" y="2949403"/>
              <a:ext cx="3280333" cy="0"/>
            </a:xfrm>
            <a:custGeom>
              <a:avLst/>
              <a:pathLst>
                <a:path w="3280333" h="0">
                  <a:moveTo>
                    <a:pt x="32803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631717" y="2949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5709025" y="4972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01763" y="4972625"/>
              <a:ext cx="3207261" cy="0"/>
            </a:xfrm>
            <a:custGeom>
              <a:avLst/>
              <a:pathLst>
                <a:path w="3207261" h="0">
                  <a:moveTo>
                    <a:pt x="32072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01763" y="4972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5723416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06722" y="4828109"/>
              <a:ext cx="3216694" cy="0"/>
            </a:xfrm>
            <a:custGeom>
              <a:avLst/>
              <a:pathLst>
                <a:path w="3216694" h="0">
                  <a:moveTo>
                    <a:pt x="32166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06722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6007040" y="1215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851014" y="1215214"/>
              <a:ext cx="3156025" cy="0"/>
            </a:xfrm>
            <a:custGeom>
              <a:avLst/>
              <a:pathLst>
                <a:path w="3156025" h="0">
                  <a:moveTo>
                    <a:pt x="31560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851014" y="1215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5825271" y="381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64602" y="3816498"/>
              <a:ext cx="3260668" cy="0"/>
            </a:xfrm>
            <a:custGeom>
              <a:avLst/>
              <a:pathLst>
                <a:path w="3260668" h="0">
                  <a:moveTo>
                    <a:pt x="32606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64602" y="381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5800973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559301" y="4105530"/>
              <a:ext cx="3241672" cy="0"/>
            </a:xfrm>
            <a:custGeom>
              <a:avLst/>
              <a:pathLst>
                <a:path w="3241672" h="0">
                  <a:moveTo>
                    <a:pt x="32416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559301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5785844" y="439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531817" y="4394561"/>
              <a:ext cx="3254026" cy="0"/>
            </a:xfrm>
            <a:custGeom>
              <a:avLst/>
              <a:pathLst>
                <a:path w="3254026" h="0">
                  <a:moveTo>
                    <a:pt x="32540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531817" y="439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6122859" y="1070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949180" y="1070698"/>
              <a:ext cx="3173679" cy="0"/>
            </a:xfrm>
            <a:custGeom>
              <a:avLst/>
              <a:pathLst>
                <a:path w="3173679" h="0">
                  <a:moveTo>
                    <a:pt x="31736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949180" y="1070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5900795" y="309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632064" y="3093919"/>
              <a:ext cx="3268730" cy="0"/>
            </a:xfrm>
            <a:custGeom>
              <a:avLst/>
              <a:pathLst>
                <a:path w="3268730" h="0">
                  <a:moveTo>
                    <a:pt x="32687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632064" y="3093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5269234" y="5550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955838" y="5550688"/>
              <a:ext cx="3313395" cy="0"/>
            </a:xfrm>
            <a:custGeom>
              <a:avLst/>
              <a:pathLst>
                <a:path w="3313395" h="0">
                  <a:moveTo>
                    <a:pt x="33133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955838" y="5550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5981283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651602" y="2082309"/>
              <a:ext cx="3329681" cy="0"/>
            </a:xfrm>
            <a:custGeom>
              <a:avLst/>
              <a:pathLst>
                <a:path w="3329681" h="0">
                  <a:moveTo>
                    <a:pt x="33296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651602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5921883" y="2371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698809" y="2371340"/>
              <a:ext cx="3223074" cy="0"/>
            </a:xfrm>
            <a:custGeom>
              <a:avLst/>
              <a:pathLst>
                <a:path w="3223074" h="0">
                  <a:moveTo>
                    <a:pt x="32230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698809" y="2371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5834177" y="3671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586612" y="3671982"/>
              <a:ext cx="3247565" cy="0"/>
            </a:xfrm>
            <a:custGeom>
              <a:avLst/>
              <a:pathLst>
                <a:path w="3247565" h="0">
                  <a:moveTo>
                    <a:pt x="32475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586612" y="3671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5926918" y="2515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672458" y="2515856"/>
              <a:ext cx="3254459" cy="0"/>
            </a:xfrm>
            <a:custGeom>
              <a:avLst/>
              <a:pathLst>
                <a:path w="3254459" h="0">
                  <a:moveTo>
                    <a:pt x="32544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672458" y="2515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5756735" y="4539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531556" y="4539077"/>
              <a:ext cx="3225178" cy="0"/>
            </a:xfrm>
            <a:custGeom>
              <a:avLst/>
              <a:pathLst>
                <a:path w="3225178" h="0">
                  <a:moveTo>
                    <a:pt x="32251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531556" y="4539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5944900" y="19377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709887" y="1937793"/>
              <a:ext cx="3235013" cy="0"/>
            </a:xfrm>
            <a:custGeom>
              <a:avLst/>
              <a:pathLst>
                <a:path w="3235013" h="0">
                  <a:moveTo>
                    <a:pt x="32350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709887" y="19377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5941330" y="1793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795670" y="1793277"/>
              <a:ext cx="3145660" cy="0"/>
            </a:xfrm>
            <a:custGeom>
              <a:avLst/>
              <a:pathLst>
                <a:path w="3145660" h="0">
                  <a:moveTo>
                    <a:pt x="31456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795670" y="1793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5646610" y="5261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495111" y="5261656"/>
              <a:ext cx="3151499" cy="0"/>
            </a:xfrm>
            <a:custGeom>
              <a:avLst/>
              <a:pathLst>
                <a:path w="3151499" h="0">
                  <a:moveTo>
                    <a:pt x="31514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495111" y="5261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5742926" y="4683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529623" y="4683593"/>
              <a:ext cx="3213303" cy="0"/>
            </a:xfrm>
            <a:custGeom>
              <a:avLst/>
              <a:pathLst>
                <a:path w="3213303" h="0">
                  <a:moveTo>
                    <a:pt x="32133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529623" y="4683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5978041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803784" y="1504245"/>
              <a:ext cx="3174257" cy="0"/>
            </a:xfrm>
            <a:custGeom>
              <a:avLst/>
              <a:pathLst>
                <a:path w="3174257" h="0">
                  <a:moveTo>
                    <a:pt x="31742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803784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5853883" y="3382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604518" y="3382951"/>
              <a:ext cx="3249364" cy="0"/>
            </a:xfrm>
            <a:custGeom>
              <a:avLst/>
              <a:pathLst>
                <a:path w="3249364" h="0">
                  <a:moveTo>
                    <a:pt x="32493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604518" y="33829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5916357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656177" y="2804888"/>
              <a:ext cx="3260180" cy="0"/>
            </a:xfrm>
            <a:custGeom>
              <a:avLst/>
              <a:pathLst>
                <a:path w="3260180" h="0">
                  <a:moveTo>
                    <a:pt x="32601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656177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5689038" y="5117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489098" y="5117140"/>
              <a:ext cx="3199939" cy="0"/>
            </a:xfrm>
            <a:custGeom>
              <a:avLst/>
              <a:pathLst>
                <a:path w="3199939" h="0">
                  <a:moveTo>
                    <a:pt x="31999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489098" y="5117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5804765" y="58397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637348" y="5839719"/>
              <a:ext cx="3167417" cy="0"/>
            </a:xfrm>
            <a:custGeom>
              <a:avLst/>
              <a:pathLst>
                <a:path w="3167417" h="0">
                  <a:moveTo>
                    <a:pt x="3167417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637348" y="58397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t151"/>
            <p:cNvSpPr/>
            <p:nvPr/>
          </p:nvSpPr>
          <p:spPr>
            <a:xfrm>
              <a:off x="4203297" y="35026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t152"/>
            <p:cNvSpPr/>
            <p:nvPr/>
          </p:nvSpPr>
          <p:spPr>
            <a:xfrm>
              <a:off x="4287494" y="2201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t153"/>
            <p:cNvSpPr/>
            <p:nvPr/>
          </p:nvSpPr>
          <p:spPr>
            <a:xfrm>
              <a:off x="4165860" y="39361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t154"/>
            <p:cNvSpPr/>
            <p:nvPr/>
          </p:nvSpPr>
          <p:spPr>
            <a:xfrm>
              <a:off x="4364788" y="16239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t155"/>
            <p:cNvSpPr/>
            <p:nvPr/>
          </p:nvSpPr>
          <p:spPr>
            <a:xfrm>
              <a:off x="3706767" y="53813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t156"/>
            <p:cNvSpPr/>
            <p:nvPr/>
          </p:nvSpPr>
          <p:spPr>
            <a:xfrm>
              <a:off x="4269650" y="26355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t157"/>
            <p:cNvSpPr/>
            <p:nvPr/>
          </p:nvSpPr>
          <p:spPr>
            <a:xfrm>
              <a:off x="4205710" y="32136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t158"/>
            <p:cNvSpPr/>
            <p:nvPr/>
          </p:nvSpPr>
          <p:spPr>
            <a:xfrm>
              <a:off x="4389461" y="13349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t159"/>
            <p:cNvSpPr/>
            <p:nvPr/>
          </p:nvSpPr>
          <p:spPr>
            <a:xfrm>
              <a:off x="4140593" y="42252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t160"/>
            <p:cNvSpPr/>
            <p:nvPr/>
          </p:nvSpPr>
          <p:spPr>
            <a:xfrm>
              <a:off x="4247058" y="29245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t161"/>
            <p:cNvSpPr/>
            <p:nvPr/>
          </p:nvSpPr>
          <p:spPr>
            <a:xfrm>
              <a:off x="4080568" y="49477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t162"/>
            <p:cNvSpPr/>
            <p:nvPr/>
          </p:nvSpPr>
          <p:spPr>
            <a:xfrm>
              <a:off x="4090243" y="4803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t163"/>
            <p:cNvSpPr/>
            <p:nvPr/>
          </p:nvSpPr>
          <p:spPr>
            <a:xfrm>
              <a:off x="4404201" y="11903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t164"/>
            <p:cNvSpPr/>
            <p:nvPr/>
          </p:nvSpPr>
          <p:spPr>
            <a:xfrm>
              <a:off x="4170111" y="3791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t165"/>
            <p:cNvSpPr/>
            <p:nvPr/>
          </p:nvSpPr>
          <p:spPr>
            <a:xfrm>
              <a:off x="4155311" y="40807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t166"/>
            <p:cNvSpPr/>
            <p:nvPr/>
          </p:nvSpPr>
          <p:spPr>
            <a:xfrm>
              <a:off x="4134005" y="43697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t167"/>
            <p:cNvSpPr/>
            <p:nvPr/>
          </p:nvSpPr>
          <p:spPr>
            <a:xfrm>
              <a:off x="4511194" y="10458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t168"/>
            <p:cNvSpPr/>
            <p:nvPr/>
          </p:nvSpPr>
          <p:spPr>
            <a:xfrm>
              <a:off x="4241603" y="30690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t169"/>
            <p:cNvSpPr/>
            <p:nvPr/>
          </p:nvSpPr>
          <p:spPr>
            <a:xfrm>
              <a:off x="3587710" y="55258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t170"/>
            <p:cNvSpPr/>
            <p:nvPr/>
          </p:nvSpPr>
          <p:spPr>
            <a:xfrm>
              <a:off x="4291616" y="20574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t171"/>
            <p:cNvSpPr/>
            <p:nvPr/>
          </p:nvSpPr>
          <p:spPr>
            <a:xfrm>
              <a:off x="4285520" y="23465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t172"/>
            <p:cNvSpPr/>
            <p:nvPr/>
          </p:nvSpPr>
          <p:spPr>
            <a:xfrm>
              <a:off x="4185568" y="36471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t173"/>
            <p:cNvSpPr/>
            <p:nvPr/>
          </p:nvSpPr>
          <p:spPr>
            <a:xfrm>
              <a:off x="4274862" y="24910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t174"/>
            <p:cNvSpPr/>
            <p:nvPr/>
          </p:nvSpPr>
          <p:spPr>
            <a:xfrm>
              <a:off x="4119319" y="45142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t175"/>
            <p:cNvSpPr/>
            <p:nvPr/>
          </p:nvSpPr>
          <p:spPr>
            <a:xfrm>
              <a:off x="4302568" y="19129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t176"/>
            <p:cNvSpPr/>
            <p:nvPr/>
          </p:nvSpPr>
          <p:spPr>
            <a:xfrm>
              <a:off x="4343674" y="17684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t177"/>
            <p:cNvSpPr/>
            <p:nvPr/>
          </p:nvSpPr>
          <p:spPr>
            <a:xfrm>
              <a:off x="4046034" y="52368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t178"/>
            <p:cNvSpPr/>
            <p:nvPr/>
          </p:nvSpPr>
          <p:spPr>
            <a:xfrm>
              <a:off x="4111448" y="46587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t179"/>
            <p:cNvSpPr/>
            <p:nvPr/>
          </p:nvSpPr>
          <p:spPr>
            <a:xfrm>
              <a:off x="4366087" y="14794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t180"/>
            <p:cNvSpPr/>
            <p:nvPr/>
          </p:nvSpPr>
          <p:spPr>
            <a:xfrm>
              <a:off x="4204374" y="33581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t181"/>
            <p:cNvSpPr/>
            <p:nvPr/>
          </p:nvSpPr>
          <p:spPr>
            <a:xfrm>
              <a:off x="4261441" y="27800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t182"/>
            <p:cNvSpPr/>
            <p:nvPr/>
          </p:nvSpPr>
          <p:spPr>
            <a:xfrm>
              <a:off x="4064242" y="50923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t183"/>
            <p:cNvSpPr/>
            <p:nvPr/>
          </p:nvSpPr>
          <p:spPr>
            <a:xfrm>
              <a:off x="4196230" y="5814894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1747487" y="56952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tx185"/>
            <p:cNvSpPr/>
            <p:nvPr/>
          </p:nvSpPr>
          <p:spPr>
            <a:xfrm>
              <a:off x="1571946" y="5803356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148183" y="551273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60261</a:t>
              </a:r>
            </a:p>
          </p:txBody>
        </p:sp>
        <p:sp>
          <p:nvSpPr>
            <p:cNvPr id="188" name="tx187"/>
            <p:cNvSpPr/>
            <p:nvPr/>
          </p:nvSpPr>
          <p:spPr>
            <a:xfrm>
              <a:off x="1204688" y="536822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81362</a:t>
              </a:r>
            </a:p>
          </p:txBody>
        </p:sp>
        <p:sp>
          <p:nvSpPr>
            <p:cNvPr id="189" name="tx188"/>
            <p:cNvSpPr/>
            <p:nvPr/>
          </p:nvSpPr>
          <p:spPr>
            <a:xfrm>
              <a:off x="1148183" y="522370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18973</a:t>
              </a:r>
            </a:p>
          </p:txBody>
        </p:sp>
        <p:sp>
          <p:nvSpPr>
            <p:cNvPr id="190" name="tx189"/>
            <p:cNvSpPr/>
            <p:nvPr/>
          </p:nvSpPr>
          <p:spPr>
            <a:xfrm>
              <a:off x="1204688" y="50791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39838</a:t>
              </a:r>
            </a:p>
          </p:txBody>
        </p:sp>
        <p:sp>
          <p:nvSpPr>
            <p:cNvPr id="191" name="tx190"/>
            <p:cNvSpPr/>
            <p:nvPr/>
          </p:nvSpPr>
          <p:spPr>
            <a:xfrm>
              <a:off x="1204688" y="493467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3784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204688" y="47902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7128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148183" y="46456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847272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148183" y="450112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35491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204688" y="435666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0262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204688" y="421209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3374</a:t>
              </a:r>
            </a:p>
          </p:txBody>
        </p:sp>
        <p:sp>
          <p:nvSpPr>
            <p:cNvPr id="197" name="tx196"/>
            <p:cNvSpPr/>
            <p:nvPr/>
          </p:nvSpPr>
          <p:spPr>
            <a:xfrm>
              <a:off x="1204688" y="406762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6221</a:t>
              </a:r>
            </a:p>
          </p:txBody>
        </p:sp>
        <p:sp>
          <p:nvSpPr>
            <p:cNvPr id="198" name="tx197"/>
            <p:cNvSpPr/>
            <p:nvPr/>
          </p:nvSpPr>
          <p:spPr>
            <a:xfrm>
              <a:off x="1148183" y="392306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70236</a:t>
              </a:r>
            </a:p>
          </p:txBody>
        </p:sp>
        <p:sp>
          <p:nvSpPr>
            <p:cNvPr id="199" name="tx198"/>
            <p:cNvSpPr/>
            <p:nvPr/>
          </p:nvSpPr>
          <p:spPr>
            <a:xfrm>
              <a:off x="1204688" y="377859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22051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04688" y="363403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55391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148183" y="348951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4852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4688" y="334504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8570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04688" y="32005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1222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04688" y="305596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18181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1261193" y="291150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949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1204688" y="27669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78102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1261193" y="2622421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321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1204688" y="247795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60791</a:t>
              </a:r>
            </a:p>
          </p:txBody>
        </p:sp>
        <p:sp>
          <p:nvSpPr>
            <p:cNvPr id="209" name="tx208"/>
            <p:cNvSpPr/>
            <p:nvPr/>
          </p:nvSpPr>
          <p:spPr>
            <a:xfrm>
              <a:off x="1204688" y="23333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1980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1148183" y="218892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22666</a:t>
              </a:r>
            </a:p>
          </p:txBody>
        </p:sp>
        <p:sp>
          <p:nvSpPr>
            <p:cNvPr id="211" name="tx210"/>
            <p:cNvSpPr/>
            <p:nvPr/>
          </p:nvSpPr>
          <p:spPr>
            <a:xfrm>
              <a:off x="1317698" y="2044357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776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1204688" y="189984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98135</a:t>
              </a:r>
            </a:p>
          </p:txBody>
        </p:sp>
        <p:sp>
          <p:nvSpPr>
            <p:cNvPr id="213" name="tx212"/>
            <p:cNvSpPr/>
            <p:nvPr/>
          </p:nvSpPr>
          <p:spPr>
            <a:xfrm>
              <a:off x="1204688" y="175537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992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1261193" y="161081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291</a:t>
              </a:r>
            </a:p>
          </p:txBody>
        </p:sp>
        <p:sp>
          <p:nvSpPr>
            <p:cNvPr id="215" name="tx214"/>
            <p:cNvSpPr/>
            <p:nvPr/>
          </p:nvSpPr>
          <p:spPr>
            <a:xfrm>
              <a:off x="1204688" y="14663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10766</a:t>
              </a:r>
            </a:p>
          </p:txBody>
        </p:sp>
        <p:sp>
          <p:nvSpPr>
            <p:cNvPr id="216" name="tx215"/>
            <p:cNvSpPr/>
            <p:nvPr/>
          </p:nvSpPr>
          <p:spPr>
            <a:xfrm>
              <a:off x="1204688" y="132177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73408</a:t>
              </a:r>
            </a:p>
          </p:txBody>
        </p:sp>
        <p:sp>
          <p:nvSpPr>
            <p:cNvPr id="217" name="tx216"/>
            <p:cNvSpPr/>
            <p:nvPr/>
          </p:nvSpPr>
          <p:spPr>
            <a:xfrm>
              <a:off x="1204688" y="117726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43784</a:t>
              </a:r>
            </a:p>
          </p:txBody>
        </p:sp>
        <p:sp>
          <p:nvSpPr>
            <p:cNvPr id="218" name="tx217"/>
            <p:cNvSpPr/>
            <p:nvPr/>
          </p:nvSpPr>
          <p:spPr>
            <a:xfrm>
              <a:off x="1204688" y="10327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6958</a:t>
              </a:r>
            </a:p>
          </p:txBody>
        </p:sp>
        <p:sp>
          <p:nvSpPr>
            <p:cNvPr id="219" name="pl218"/>
            <p:cNvSpPr/>
            <p:nvPr/>
          </p:nvSpPr>
          <p:spPr>
            <a:xfrm>
              <a:off x="1712693" y="58397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1712693" y="56952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1712693" y="55506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1712693" y="54061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1712693" y="52616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1712693" y="51171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1712693" y="49726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712693" y="48281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1712693" y="4683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1712693" y="4539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1712693" y="43945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1712693" y="42500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1712693" y="41055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1712693" y="39610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1712693" y="38164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1712693" y="36719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1712693" y="35274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1712693" y="33829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1712693" y="32384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712693" y="30939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712693" y="29494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1712693" y="28048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1712693" y="26603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1712693" y="25158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1712693" y="23713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712693" y="22268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712693" y="20823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1712693" y="19377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1712693" y="17932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1712693" y="16487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1712693" y="15042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1712693" y="13597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1712693" y="12152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1712693" y="10706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30336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313094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395852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478609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561367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tx257"/>
            <p:cNvSpPr/>
            <p:nvPr/>
          </p:nvSpPr>
          <p:spPr>
            <a:xfrm>
              <a:off x="2132453" y="5987367"/>
              <a:ext cx="3418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0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2960030" y="5987367"/>
              <a:ext cx="3418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5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3787606" y="5987367"/>
              <a:ext cx="3418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10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4615183" y="5987367"/>
              <a:ext cx="3418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15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5442760" y="5987367"/>
              <a:ext cx="3418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20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264" name="tx263"/>
            <p:cNvSpPr/>
            <p:nvPr/>
          </p:nvSpPr>
          <p:spPr>
            <a:xfrm>
              <a:off x="2319367" y="6214430"/>
              <a:ext cx="3439963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exposure' on 'Operation code: pilonidal sinus surgery (anal) || id:ukb-b-561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0:53:28Z</dcterms:modified>
  <cp:category/>
</cp:coreProperties>
</file>